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835" autoAdjust="0"/>
  </p:normalViewPr>
  <p:slideViewPr>
    <p:cSldViewPr snapToGrid="0" snapToObjects="1">
      <p:cViewPr varScale="1">
        <p:scale>
          <a:sx n="57" d="100"/>
          <a:sy n="57" d="100"/>
        </p:scale>
        <p:origin x="2688" y="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SARAH%202016:MSc%202016%20:Results:Microscopy:Phase%20contrast%20(lab%20microscope):CaSki%20relative%20cell%20area%20comparison%20(8.10.16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SARAH%202016:MSc%202016%20:Results:CaSki%20stable%20adhesion%20assay%20(30.9.16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Sarah's%20paper\Copy%20of%20Cytoplasmic%20extensions%20quantification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Sarah's%20paper\Analysis%20of%20migration_Ronk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929171764732201"/>
          <c:y val="0.20583308525769201"/>
          <c:w val="0.704650156002807"/>
          <c:h val="0.658199608749272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C$11;Sheet1!$C$24)</c:f>
                <c:numCache>
                  <c:formatCode>General</c:formatCode>
                  <c:ptCount val="2"/>
                  <c:pt idx="0">
                    <c:v>8.8440038460908907E-2</c:v>
                  </c:pt>
                  <c:pt idx="1">
                    <c:v>3.46882130302390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1:$E$2</c:f>
              <c:strCache>
                <c:ptCount val="2"/>
                <c:pt idx="0">
                  <c:v>EGFP</c:v>
                </c:pt>
                <c:pt idx="1">
                  <c:v>Kpnβ1-EGFP</c:v>
                </c:pt>
              </c:strCache>
            </c:strRef>
          </c:cat>
          <c:val>
            <c:numRef>
              <c:f>(Sheet1!$C$10;Sheet1!$C$23)</c:f>
              <c:numCache>
                <c:formatCode>General</c:formatCode>
                <c:ptCount val="2"/>
                <c:pt idx="0">
                  <c:v>1</c:v>
                </c:pt>
                <c:pt idx="1">
                  <c:v>0.650601764891607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8A-4909-9162-9118A5907A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978432"/>
        <c:axId val="138979968"/>
      </c:barChart>
      <c:catAx>
        <c:axId val="138978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j-lt"/>
              </a:defRPr>
            </a:pPr>
            <a:endParaRPr lang="en-US"/>
          </a:p>
        </c:txPr>
        <c:crossAx val="138979968"/>
        <c:crosses val="autoZero"/>
        <c:auto val="1"/>
        <c:lblAlgn val="ctr"/>
        <c:lblOffset val="100"/>
        <c:noMultiLvlLbl val="0"/>
      </c:catAx>
      <c:valAx>
        <c:axId val="1389799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800">
                    <a:latin typeface="+mj-lt"/>
                  </a:defRPr>
                </a:pPr>
                <a:r>
                  <a:rPr lang="en-US" sz="800" dirty="0">
                    <a:latin typeface="+mj-lt"/>
                  </a:rPr>
                  <a:t>Relative cell area</a:t>
                </a:r>
              </a:p>
            </c:rich>
          </c:tx>
          <c:layout>
            <c:manualLayout>
              <c:xMode val="edge"/>
              <c:yMode val="edge"/>
              <c:x val="1.67876949126156E-3"/>
              <c:y val="0.235697848593528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j-lt"/>
              </a:defRPr>
            </a:pPr>
            <a:endParaRPr lang="en-US"/>
          </a:p>
        </c:txPr>
        <c:crossAx val="138978432"/>
        <c:crosses val="autoZero"/>
        <c:crossBetween val="between"/>
        <c:majorUnit val="0.4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781122466476901"/>
          <c:y val="6.0185185185185203E-2"/>
          <c:w val="0.725932816626084"/>
          <c:h val="0.801506279649929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10:$J$10</c:f>
                <c:numCache>
                  <c:formatCode>General</c:formatCode>
                  <c:ptCount val="2"/>
                  <c:pt idx="0">
                    <c:v>4.3327003541987798E-2</c:v>
                  </c:pt>
                  <c:pt idx="1">
                    <c:v>5.119229413455649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20:$C$20</c:f>
              <c:strCache>
                <c:ptCount val="2"/>
                <c:pt idx="0">
                  <c:v>EGFP</c:v>
                </c:pt>
                <c:pt idx="1">
                  <c:v>Kpnβ1-EGFP</c:v>
                </c:pt>
              </c:strCache>
            </c:strRef>
          </c:cat>
          <c:val>
            <c:numRef>
              <c:f>Sheet1!$B$21:$C$21</c:f>
              <c:numCache>
                <c:formatCode>General</c:formatCode>
                <c:ptCount val="2"/>
                <c:pt idx="0">
                  <c:v>1</c:v>
                </c:pt>
                <c:pt idx="1">
                  <c:v>1.2641975308641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DA-4827-BD79-E0BD2D27A4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006400"/>
        <c:axId val="40007936"/>
      </c:barChart>
      <c:catAx>
        <c:axId val="40006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j-lt"/>
              </a:defRPr>
            </a:pPr>
            <a:endParaRPr lang="en-US"/>
          </a:p>
        </c:txPr>
        <c:crossAx val="40007936"/>
        <c:crosses val="autoZero"/>
        <c:auto val="1"/>
        <c:lblAlgn val="ctr"/>
        <c:lblOffset val="100"/>
        <c:noMultiLvlLbl val="0"/>
      </c:catAx>
      <c:valAx>
        <c:axId val="40007936"/>
        <c:scaling>
          <c:orientation val="minMax"/>
          <c:max val="2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800">
                    <a:latin typeface="+mj-lt"/>
                  </a:defRPr>
                </a:pPr>
                <a:r>
                  <a:rPr lang="en-US" sz="800">
                    <a:latin typeface="+mj-lt"/>
                  </a:rPr>
                  <a:t>Relative adhesion</a:t>
                </a:r>
              </a:p>
            </c:rich>
          </c:tx>
          <c:layout>
            <c:manualLayout>
              <c:xMode val="edge"/>
              <c:yMode val="edge"/>
              <c:x val="2.23640213999108E-2"/>
              <c:y val="0.233088192409397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j-lt"/>
              </a:defRPr>
            </a:pPr>
            <a:endParaRPr lang="en-US"/>
          </a:p>
        </c:txPr>
        <c:crossAx val="40006400"/>
        <c:crosses val="autoZero"/>
        <c:crossBetween val="between"/>
        <c:majorUnit val="0.4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>
              <a:outerShdw sx="1000" sy="1000" rotWithShape="0">
                <a:srgbClr val="000000"/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'C:\var\folders\t9\rdq9978d23q_wjvpqp3c0gp0pdv6c9\T\com.microsoft.Outlook\Outlook Temp\[HeLa cyto extensions.xlsx]Sheet1'!$B$16:$C$16</c:f>
                <c:numCache>
                  <c:formatCode>General</c:formatCode>
                  <c:ptCount val="2"/>
                  <c:pt idx="0">
                    <c:v>0.38873012632302034</c:v>
                  </c:pt>
                  <c:pt idx="1">
                    <c:v>0.45825756949558394</c:v>
                  </c:pt>
                </c:numCache>
              </c:numRef>
            </c:plus>
            <c:minus>
              <c:numRef>
                <c:f>'C:\var\folders\t9\rdq9978d23q_wjvpqp3c0gp0pdv6c9\T\com.microsoft.Outlook\Outlook Temp\[HeLa cyto extensions.xlsx]Sheet1'!$B$16:$C$16</c:f>
                <c:numCache>
                  <c:formatCode>General</c:formatCode>
                  <c:ptCount val="2"/>
                  <c:pt idx="0">
                    <c:v>0.38873012632302034</c:v>
                  </c:pt>
                  <c:pt idx="1">
                    <c:v>0.45825756949558394</c:v>
                  </c:pt>
                </c:numCache>
              </c:numRef>
            </c:minus>
          </c:errBars>
          <c:cat>
            <c:strRef>
              <c:f>Sheet1!$B$5:$C$5</c:f>
              <c:strCache>
                <c:ptCount val="2"/>
                <c:pt idx="0">
                  <c:v>EGFP</c:v>
                </c:pt>
                <c:pt idx="1">
                  <c:v>Kpnβ1-EGFP</c:v>
                </c:pt>
              </c:strCache>
            </c:strRef>
          </c:cat>
          <c:val>
            <c:numRef>
              <c:f>Sheet1!$B$6:$C$6</c:f>
              <c:numCache>
                <c:formatCode>General</c:formatCode>
                <c:ptCount val="2"/>
                <c:pt idx="0">
                  <c:v>6.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54-4611-B42F-3750F50509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307328"/>
        <c:axId val="40325504"/>
      </c:barChart>
      <c:catAx>
        <c:axId val="403073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0325504"/>
        <c:crosses val="autoZero"/>
        <c:auto val="1"/>
        <c:lblAlgn val="ctr"/>
        <c:lblOffset val="100"/>
        <c:noMultiLvlLbl val="0"/>
      </c:catAx>
      <c:valAx>
        <c:axId val="4032550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Number of cytoplasmic extensions/cell</a:t>
                </a:r>
              </a:p>
            </c:rich>
          </c:tx>
          <c:layout>
            <c:manualLayout>
              <c:xMode val="edge"/>
              <c:yMode val="edge"/>
              <c:x val="3.0620032960996201E-2"/>
              <c:y val="0.20881709786276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03073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84706980525071"/>
          <c:y val="5.1400554097404488E-2"/>
          <c:w val="0.79401535191959272"/>
          <c:h val="0.73444808982210552"/>
        </c:manualLayout>
      </c:layout>
      <c:barChart>
        <c:barDir val="col"/>
        <c:grouping val="clustered"/>
        <c:varyColors val="0"/>
        <c:ser>
          <c:idx val="0"/>
          <c:order val="0"/>
          <c:tx>
            <c:v>EGFP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G$3,Sheet1!$G$6,Sheet1!$G$9,Sheet1!$G$12)</c:f>
                <c:numCache>
                  <c:formatCode>General</c:formatCode>
                  <c:ptCount val="4"/>
                  <c:pt idx="0">
                    <c:v>30.529213949617596</c:v>
                  </c:pt>
                  <c:pt idx="1">
                    <c:v>11.101381884568436</c:v>
                  </c:pt>
                  <c:pt idx="2">
                    <c:v>8.1736477207727596</c:v>
                  </c:pt>
                  <c:pt idx="3">
                    <c:v>2.50288764635386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3</c:v>
              </c:pt>
              <c:pt idx="2">
                <c:v>6</c:v>
              </c:pt>
              <c:pt idx="3">
                <c:v>24</c:v>
              </c:pt>
            </c:numLit>
          </c:cat>
          <c:val>
            <c:numRef>
              <c:f>(Sheet1!$F$3,Sheet1!$F$6,Sheet1!$F$9,Sheet1!$F$12)</c:f>
              <c:numCache>
                <c:formatCode>General</c:formatCode>
                <c:ptCount val="4"/>
                <c:pt idx="0">
                  <c:v>100</c:v>
                </c:pt>
                <c:pt idx="1">
                  <c:v>71.372761979881929</c:v>
                </c:pt>
                <c:pt idx="2">
                  <c:v>63.240417112808508</c:v>
                </c:pt>
                <c:pt idx="3">
                  <c:v>33.2761531153362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AB-4004-A1E6-2C440D4353A5}"/>
            </c:ext>
          </c:extLst>
        </c:ser>
        <c:ser>
          <c:idx val="1"/>
          <c:order val="1"/>
          <c:tx>
            <c:v>Kpnβ1-EGFP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R$3,Sheet1!$R$6,Sheet1!$R$9,Sheet1!$R$12)</c:f>
                <c:numCache>
                  <c:formatCode>General</c:formatCode>
                  <c:ptCount val="4"/>
                  <c:pt idx="0">
                    <c:v>14.216774842385096</c:v>
                  </c:pt>
                  <c:pt idx="1">
                    <c:v>6.2819115468148388</c:v>
                  </c:pt>
                  <c:pt idx="2">
                    <c:v>11.35543717861491</c:v>
                  </c:pt>
                  <c:pt idx="3">
                    <c:v>16.2984661015241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Sheet1!$Q$3,Sheet1!$Q$6,Sheet1!$Q$9,Sheet1!$Q$12)</c:f>
              <c:numCache>
                <c:formatCode>General</c:formatCode>
                <c:ptCount val="4"/>
                <c:pt idx="0">
                  <c:v>100</c:v>
                </c:pt>
                <c:pt idx="1">
                  <c:v>70.881744141848074</c:v>
                </c:pt>
                <c:pt idx="2">
                  <c:v>63.786715695489271</c:v>
                </c:pt>
                <c:pt idx="3">
                  <c:v>27.336101228848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6AB-4004-A1E6-2C440D4353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379904"/>
        <c:axId val="40381824"/>
      </c:barChart>
      <c:catAx>
        <c:axId val="40379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post scratch (hours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0381824"/>
        <c:crosses val="autoZero"/>
        <c:auto val="1"/>
        <c:lblAlgn val="ctr"/>
        <c:lblOffset val="100"/>
        <c:noMultiLvlLbl val="0"/>
      </c:catAx>
      <c:valAx>
        <c:axId val="403818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Gap (%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03799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995933825200972"/>
          <c:y val="1.3505030621172356E-2"/>
          <c:w val="0.31004066174799016"/>
          <c:h val="0.1674343832020997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653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419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883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85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770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94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559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203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928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29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883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C7BFC-A7E3-1143-8092-1A977D1AC26C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4BB93-A4F4-AD45-B3A1-BAAC14844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619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9.jpeg"/><Relationship Id="rId18" Type="http://schemas.openxmlformats.org/officeDocument/2006/relationships/image" Target="../media/image13.jpeg"/><Relationship Id="rId3" Type="http://schemas.openxmlformats.org/officeDocument/2006/relationships/image" Target="../media/image1.tiff"/><Relationship Id="rId21" Type="http://schemas.microsoft.com/office/2007/relationships/hdphoto" Target="../media/hdphoto2.wdp"/><Relationship Id="rId7" Type="http://schemas.openxmlformats.org/officeDocument/2006/relationships/chart" Target="../charts/chart2.xml"/><Relationship Id="rId12" Type="http://schemas.openxmlformats.org/officeDocument/2006/relationships/chart" Target="../charts/chart3.xml"/><Relationship Id="rId17" Type="http://schemas.openxmlformats.org/officeDocument/2006/relationships/image" Target="../media/image12.jpeg"/><Relationship Id="rId2" Type="http://schemas.openxmlformats.org/officeDocument/2006/relationships/chart" Target="../charts/chart1.xml"/><Relationship Id="rId16" Type="http://schemas.microsoft.com/office/2007/relationships/hdphoto" Target="../media/hdphoto1.wdp"/><Relationship Id="rId20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8.jpeg"/><Relationship Id="rId5" Type="http://schemas.openxmlformats.org/officeDocument/2006/relationships/image" Target="../media/image3.png"/><Relationship Id="rId15" Type="http://schemas.openxmlformats.org/officeDocument/2006/relationships/image" Target="../media/image11.jpeg"/><Relationship Id="rId23" Type="http://schemas.openxmlformats.org/officeDocument/2006/relationships/chart" Target="../charts/chart4.xml"/><Relationship Id="rId10" Type="http://schemas.openxmlformats.org/officeDocument/2006/relationships/image" Target="../media/image7.jpeg"/><Relationship Id="rId19" Type="http://schemas.openxmlformats.org/officeDocument/2006/relationships/image" Target="../media/image14.jpeg"/><Relationship Id="rId4" Type="http://schemas.openxmlformats.org/officeDocument/2006/relationships/image" Target="../media/image2.jpeg"/><Relationship Id="rId9" Type="http://schemas.openxmlformats.org/officeDocument/2006/relationships/image" Target="../media/image6.jpeg"/><Relationship Id="rId14" Type="http://schemas.openxmlformats.org/officeDocument/2006/relationships/image" Target="../media/image10.jpeg"/><Relationship Id="rId22" Type="http://schemas.openxmlformats.org/officeDocument/2006/relationships/image" Target="../media/image1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405514" y="1056901"/>
            <a:ext cx="17378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900" b="1" dirty="0"/>
              <a:t>EGFP</a:t>
            </a:r>
            <a:endParaRPr lang="en-ZA" sz="1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178473" y="1056901"/>
            <a:ext cx="1756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900" b="1" dirty="0"/>
              <a:t>Kpn</a:t>
            </a:r>
            <a:r>
              <a:rPr lang="en-GB" sz="900" dirty="0"/>
              <a:t>β</a:t>
            </a:r>
            <a:r>
              <a:rPr lang="en-ZA" sz="900" b="1" dirty="0"/>
              <a:t>1-EGFP</a:t>
            </a: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6045167"/>
              </p:ext>
            </p:extLst>
          </p:nvPr>
        </p:nvGraphicFramePr>
        <p:xfrm>
          <a:off x="4112333" y="1116513"/>
          <a:ext cx="2286794" cy="16930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0" name="Group 9"/>
          <p:cNvGrpSpPr/>
          <p:nvPr/>
        </p:nvGrpSpPr>
        <p:grpSpPr>
          <a:xfrm>
            <a:off x="5066288" y="1118905"/>
            <a:ext cx="797820" cy="261772"/>
            <a:chOff x="5909972" y="1101843"/>
            <a:chExt cx="325867" cy="261771"/>
          </a:xfrm>
        </p:grpSpPr>
        <p:sp>
          <p:nvSpPr>
            <p:cNvPr id="11" name="Left Bracket 10"/>
            <p:cNvSpPr/>
            <p:nvPr/>
          </p:nvSpPr>
          <p:spPr>
            <a:xfrm rot="5400000">
              <a:off x="6051678" y="1179454"/>
              <a:ext cx="45721" cy="322600"/>
            </a:xfrm>
            <a:prstGeom prst="leftBracket">
              <a:avLst/>
            </a:prstGeom>
            <a:noFill/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909972" y="1101843"/>
              <a:ext cx="322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*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440665" y="1264160"/>
            <a:ext cx="3510767" cy="1431775"/>
            <a:chOff x="440665" y="565660"/>
            <a:chExt cx="3510767" cy="1431775"/>
          </a:xfrm>
        </p:grpSpPr>
        <p:pic>
          <p:nvPicPr>
            <p:cNvPr id="4" name="Picture 3" descr="CaSki EGFP.tiff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0665" y="565660"/>
              <a:ext cx="1737808" cy="143177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Picture 4" descr="CaSki pool 1 2.tiff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13624" y="565660"/>
              <a:ext cx="1737808" cy="1431775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3" name="Group 12"/>
            <p:cNvGrpSpPr/>
            <p:nvPr/>
          </p:nvGrpSpPr>
          <p:grpSpPr>
            <a:xfrm>
              <a:off x="1804807" y="1765551"/>
              <a:ext cx="349142" cy="176133"/>
              <a:chOff x="5210326" y="4275244"/>
              <a:chExt cx="349142" cy="176133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5269831" y="4370904"/>
                <a:ext cx="234222" cy="80473"/>
                <a:chOff x="5269831" y="4370904"/>
                <a:chExt cx="234222" cy="80473"/>
              </a:xfrm>
            </p:grpSpPr>
            <p:cxnSp>
              <p:nvCxnSpPr>
                <p:cNvPr id="16" name="Straight Connector 15"/>
                <p:cNvCxnSpPr/>
                <p:nvPr/>
              </p:nvCxnSpPr>
              <p:spPr>
                <a:xfrm>
                  <a:off x="5272049" y="4410927"/>
                  <a:ext cx="229526" cy="0"/>
                </a:xfrm>
                <a:prstGeom prst="line">
                  <a:avLst/>
                </a:prstGeom>
                <a:ln w="635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/>
                <p:cNvCxnSpPr/>
                <p:nvPr/>
              </p:nvCxnSpPr>
              <p:spPr>
                <a:xfrm>
                  <a:off x="5269831" y="4370904"/>
                  <a:ext cx="1" cy="80473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5504052" y="4370904"/>
                  <a:ext cx="1" cy="80473"/>
                </a:xfrm>
                <a:prstGeom prst="line">
                  <a:avLst/>
                </a:prstGeom>
                <a:ln w="635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" name="TextBox 14"/>
              <p:cNvSpPr txBox="1"/>
              <p:nvPr/>
            </p:nvSpPr>
            <p:spPr>
              <a:xfrm>
                <a:off x="5210326" y="4275244"/>
                <a:ext cx="34914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/>
                  <a:t>50</a:t>
                </a:r>
                <a:r>
                  <a:rPr lang="en-GB" sz="500" dirty="0">
                    <a:sym typeface="Symbol"/>
                  </a:rPr>
                  <a:t></a:t>
                </a:r>
                <a:r>
                  <a:rPr lang="en-GB" sz="500" dirty="0"/>
                  <a:t>M</a:t>
                </a:r>
                <a:endParaRPr lang="en-US" sz="500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577049" y="1771166"/>
              <a:ext cx="349142" cy="176133"/>
              <a:chOff x="5210326" y="4275244"/>
              <a:chExt cx="349142" cy="176133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5269831" y="4370904"/>
                <a:ext cx="234222" cy="80473"/>
                <a:chOff x="5269831" y="4370904"/>
                <a:chExt cx="234222" cy="80473"/>
              </a:xfrm>
            </p:grpSpPr>
            <p:cxnSp>
              <p:nvCxnSpPr>
                <p:cNvPr id="22" name="Straight Connector 21"/>
                <p:cNvCxnSpPr/>
                <p:nvPr/>
              </p:nvCxnSpPr>
              <p:spPr>
                <a:xfrm>
                  <a:off x="5272049" y="4410927"/>
                  <a:ext cx="229526" cy="0"/>
                </a:xfrm>
                <a:prstGeom prst="line">
                  <a:avLst/>
                </a:prstGeom>
                <a:ln w="635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/>
                <p:cNvCxnSpPr/>
                <p:nvPr/>
              </p:nvCxnSpPr>
              <p:spPr>
                <a:xfrm>
                  <a:off x="5269831" y="4370904"/>
                  <a:ext cx="1" cy="80473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/>
                <p:cNvCxnSpPr/>
                <p:nvPr/>
              </p:nvCxnSpPr>
              <p:spPr>
                <a:xfrm>
                  <a:off x="5504052" y="4370904"/>
                  <a:ext cx="1" cy="80473"/>
                </a:xfrm>
                <a:prstGeom prst="line">
                  <a:avLst/>
                </a:prstGeom>
                <a:ln w="635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" name="TextBox 20"/>
              <p:cNvSpPr txBox="1"/>
              <p:nvPr/>
            </p:nvSpPr>
            <p:spPr>
              <a:xfrm>
                <a:off x="5210326" y="4275244"/>
                <a:ext cx="34914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/>
                  <a:t>50</a:t>
                </a:r>
                <a:r>
                  <a:rPr lang="en-GB" sz="500" dirty="0">
                    <a:sym typeface="Symbol"/>
                  </a:rPr>
                  <a:t></a:t>
                </a:r>
                <a:r>
                  <a:rPr lang="en-GB" sz="500" dirty="0"/>
                  <a:t>M</a:t>
                </a:r>
                <a:endParaRPr lang="en-US" sz="500" dirty="0"/>
              </a:p>
            </p:txBody>
          </p:sp>
        </p:grpSp>
      </p:grpSp>
      <p:pic>
        <p:nvPicPr>
          <p:cNvPr id="26" name="Picture 2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94775" y="3145453"/>
            <a:ext cx="1731416" cy="1352593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3653" y="3145453"/>
            <a:ext cx="1743699" cy="1352593"/>
          </a:xfrm>
          <a:prstGeom prst="rect">
            <a:avLst/>
          </a:prstGeom>
        </p:spPr>
      </p:pic>
      <p:grpSp>
        <p:nvGrpSpPr>
          <p:cNvPr id="67" name="Group 66"/>
          <p:cNvGrpSpPr/>
          <p:nvPr/>
        </p:nvGrpSpPr>
        <p:grpSpPr>
          <a:xfrm>
            <a:off x="1844118" y="4233146"/>
            <a:ext cx="349142" cy="226248"/>
            <a:chOff x="5238301" y="4225129"/>
            <a:chExt cx="349142" cy="226248"/>
          </a:xfrm>
        </p:grpSpPr>
        <p:grpSp>
          <p:nvGrpSpPr>
            <p:cNvPr id="68" name="Group 67"/>
            <p:cNvGrpSpPr/>
            <p:nvPr/>
          </p:nvGrpSpPr>
          <p:grpSpPr>
            <a:xfrm>
              <a:off x="5334494" y="4370904"/>
              <a:ext cx="169559" cy="80473"/>
              <a:chOff x="5334494" y="4370904"/>
              <a:chExt cx="169559" cy="80473"/>
            </a:xfrm>
          </p:grpSpPr>
          <p:cxnSp>
            <p:nvCxnSpPr>
              <p:cNvPr id="70" name="Straight Connector 69"/>
              <p:cNvCxnSpPr/>
              <p:nvPr/>
            </p:nvCxnSpPr>
            <p:spPr>
              <a:xfrm>
                <a:off x="5334494" y="4410927"/>
                <a:ext cx="167081" cy="0"/>
              </a:xfrm>
              <a:prstGeom prst="line">
                <a:avLst/>
              </a:prstGeom>
              <a:ln w="63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/>
              <p:nvPr/>
            </p:nvCxnSpPr>
            <p:spPr>
              <a:xfrm>
                <a:off x="5336971" y="4370904"/>
                <a:ext cx="1" cy="80473"/>
              </a:xfrm>
              <a:prstGeom prst="line">
                <a:avLst/>
              </a:prstGeom>
              <a:ln w="63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>
                <a:off x="5504052" y="4370904"/>
                <a:ext cx="1" cy="80473"/>
              </a:xfrm>
              <a:prstGeom prst="line">
                <a:avLst/>
              </a:prstGeom>
              <a:ln w="63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TextBox 68"/>
            <p:cNvSpPr txBox="1"/>
            <p:nvPr/>
          </p:nvSpPr>
          <p:spPr>
            <a:xfrm>
              <a:off x="5238301" y="4225129"/>
              <a:ext cx="3491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>
                  <a:solidFill>
                    <a:srgbClr val="FF0000"/>
                  </a:solidFill>
                </a:rPr>
                <a:t>10</a:t>
              </a:r>
              <a:r>
                <a:rPr lang="en-GB" sz="500" dirty="0">
                  <a:solidFill>
                    <a:srgbClr val="FF0000"/>
                  </a:solidFill>
                  <a:sym typeface="Symbol"/>
                </a:rPr>
                <a:t></a:t>
              </a:r>
              <a:r>
                <a:rPr lang="en-GB" sz="500" dirty="0">
                  <a:solidFill>
                    <a:srgbClr val="FF0000"/>
                  </a:solidFill>
                </a:rPr>
                <a:t>M</a:t>
              </a:r>
              <a:endParaRPr lang="en-US" sz="5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3597623" y="4263363"/>
            <a:ext cx="349142" cy="199008"/>
            <a:chOff x="5238301" y="4252369"/>
            <a:chExt cx="349142" cy="199008"/>
          </a:xfrm>
        </p:grpSpPr>
        <p:grpSp>
          <p:nvGrpSpPr>
            <p:cNvPr id="74" name="Group 73"/>
            <p:cNvGrpSpPr/>
            <p:nvPr/>
          </p:nvGrpSpPr>
          <p:grpSpPr>
            <a:xfrm>
              <a:off x="5334494" y="4370904"/>
              <a:ext cx="169559" cy="80473"/>
              <a:chOff x="5334494" y="4370904"/>
              <a:chExt cx="169559" cy="80473"/>
            </a:xfrm>
          </p:grpSpPr>
          <p:cxnSp>
            <p:nvCxnSpPr>
              <p:cNvPr id="76" name="Straight Connector 75"/>
              <p:cNvCxnSpPr/>
              <p:nvPr/>
            </p:nvCxnSpPr>
            <p:spPr>
              <a:xfrm>
                <a:off x="5334494" y="4410927"/>
                <a:ext cx="167081" cy="0"/>
              </a:xfrm>
              <a:prstGeom prst="line">
                <a:avLst/>
              </a:prstGeom>
              <a:ln w="63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/>
              <p:nvPr/>
            </p:nvCxnSpPr>
            <p:spPr>
              <a:xfrm>
                <a:off x="5336971" y="4370904"/>
                <a:ext cx="1" cy="80473"/>
              </a:xfrm>
              <a:prstGeom prst="line">
                <a:avLst/>
              </a:prstGeom>
              <a:ln w="63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5504052" y="4370904"/>
                <a:ext cx="1" cy="80473"/>
              </a:xfrm>
              <a:prstGeom prst="line">
                <a:avLst/>
              </a:prstGeom>
              <a:ln w="63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5" name="TextBox 74"/>
            <p:cNvSpPr txBox="1"/>
            <p:nvPr/>
          </p:nvSpPr>
          <p:spPr>
            <a:xfrm>
              <a:off x="5238301" y="4252369"/>
              <a:ext cx="3491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>
                  <a:solidFill>
                    <a:srgbClr val="FF0000"/>
                  </a:solidFill>
                </a:rPr>
                <a:t>10</a:t>
              </a:r>
              <a:r>
                <a:rPr lang="en-GB" sz="500" dirty="0">
                  <a:solidFill>
                    <a:srgbClr val="FF0000"/>
                  </a:solidFill>
                  <a:sym typeface="Symbol"/>
                </a:rPr>
                <a:t></a:t>
              </a:r>
              <a:r>
                <a:rPr lang="en-GB" sz="500" dirty="0">
                  <a:solidFill>
                    <a:srgbClr val="FF0000"/>
                  </a:solidFill>
                </a:rPr>
                <a:t>M</a:t>
              </a:r>
              <a:endParaRPr lang="en-US" sz="5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139360" y="2934217"/>
            <a:ext cx="797818" cy="261772"/>
            <a:chOff x="5909972" y="1101843"/>
            <a:chExt cx="325866" cy="261771"/>
          </a:xfrm>
        </p:grpSpPr>
        <p:sp>
          <p:nvSpPr>
            <p:cNvPr id="81" name="Left Bracket 80"/>
            <p:cNvSpPr/>
            <p:nvPr/>
          </p:nvSpPr>
          <p:spPr>
            <a:xfrm rot="5400000">
              <a:off x="6051677" y="1179454"/>
              <a:ext cx="45721" cy="322600"/>
            </a:xfrm>
            <a:prstGeom prst="leftBracket">
              <a:avLst/>
            </a:prstGeom>
            <a:noFill/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5909972" y="1101843"/>
              <a:ext cx="322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*</a:t>
              </a:r>
            </a:p>
          </p:txBody>
        </p:sp>
      </p:grpSp>
      <p:graphicFrame>
        <p:nvGraphicFramePr>
          <p:cNvPr id="83" name="Chart 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409442"/>
              </p:ext>
            </p:extLst>
          </p:nvPr>
        </p:nvGraphicFramePr>
        <p:xfrm>
          <a:off x="480712" y="5058925"/>
          <a:ext cx="2332720" cy="18174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86" name="Group 85"/>
          <p:cNvGrpSpPr/>
          <p:nvPr/>
        </p:nvGrpSpPr>
        <p:grpSpPr>
          <a:xfrm>
            <a:off x="1480157" y="5224352"/>
            <a:ext cx="816009" cy="261771"/>
            <a:chOff x="5909972" y="1101843"/>
            <a:chExt cx="325867" cy="261771"/>
          </a:xfrm>
        </p:grpSpPr>
        <p:sp>
          <p:nvSpPr>
            <p:cNvPr id="87" name="Left Bracket 86"/>
            <p:cNvSpPr/>
            <p:nvPr/>
          </p:nvSpPr>
          <p:spPr>
            <a:xfrm rot="5400000">
              <a:off x="6051678" y="1179454"/>
              <a:ext cx="45721" cy="322600"/>
            </a:xfrm>
            <a:prstGeom prst="leftBracket">
              <a:avLst/>
            </a:prstGeom>
            <a:noFill/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5909972" y="1101843"/>
              <a:ext cx="322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*</a:t>
              </a:r>
            </a:p>
          </p:txBody>
        </p:sp>
      </p:grpSp>
      <p:sp>
        <p:nvSpPr>
          <p:cNvPr id="93" name="Text Box 5"/>
          <p:cNvSpPr txBox="1"/>
          <p:nvPr/>
        </p:nvSpPr>
        <p:spPr>
          <a:xfrm>
            <a:off x="4978271" y="5262443"/>
            <a:ext cx="1088390" cy="448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5" name="Text Box 9"/>
          <p:cNvSpPr txBox="1"/>
          <p:nvPr/>
        </p:nvSpPr>
        <p:spPr>
          <a:xfrm rot="16200000">
            <a:off x="1319423" y="6511123"/>
            <a:ext cx="1428115" cy="262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6" name="Text Box 10"/>
          <p:cNvSpPr txBox="1"/>
          <p:nvPr/>
        </p:nvSpPr>
        <p:spPr>
          <a:xfrm rot="16200000">
            <a:off x="892182" y="6511125"/>
            <a:ext cx="1427480" cy="262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/>
          </a:p>
        </p:txBody>
      </p:sp>
      <p:grpSp>
        <p:nvGrpSpPr>
          <p:cNvPr id="113" name="Group 112"/>
          <p:cNvGrpSpPr/>
          <p:nvPr/>
        </p:nvGrpSpPr>
        <p:grpSpPr>
          <a:xfrm>
            <a:off x="3888325" y="4430261"/>
            <a:ext cx="2829885" cy="2334613"/>
            <a:chOff x="3939125" y="4519161"/>
            <a:chExt cx="2829885" cy="2334613"/>
          </a:xfrm>
        </p:grpSpPr>
        <p:pic>
          <p:nvPicPr>
            <p:cNvPr id="89" name="Picture 88" descr="CaSki stables adhesion proteins (13.9.16).jpeg"/>
            <p:cNvPicPr>
              <a:picLocks noChangeAspect="1"/>
            </p:cNvPicPr>
            <p:nvPr/>
          </p:nvPicPr>
          <p:blipFill rotWithShape="1">
            <a:blip r:embed="rId8" cstate="print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39125" y="6559760"/>
              <a:ext cx="842880" cy="2940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0" name="Picture 89" descr="CaSki stables adhesion proteins (13.9.16).jpeg"/>
            <p:cNvPicPr>
              <a:picLocks noChangeAspect="1"/>
            </p:cNvPicPr>
            <p:nvPr/>
          </p:nvPicPr>
          <p:blipFill rotWithShape="1">
            <a:blip r:embed="rId9" cstate="print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5976" b="1"/>
            <a:stretch/>
          </p:blipFill>
          <p:spPr>
            <a:xfrm>
              <a:off x="3943952" y="6207894"/>
              <a:ext cx="838053" cy="2949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1" name="Picture 90" descr="CaSki stables adhesion proteins (13.9.16).jpeg"/>
            <p:cNvPicPr>
              <a:picLocks noChangeAspect="1"/>
            </p:cNvPicPr>
            <p:nvPr/>
          </p:nvPicPr>
          <p:blipFill rotWithShape="1">
            <a:blip r:embed="rId10" cstate="print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10601"/>
            <a:stretch/>
          </p:blipFill>
          <p:spPr>
            <a:xfrm>
              <a:off x="3943952" y="5810494"/>
              <a:ext cx="831265" cy="3404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2" name="Picture 91" descr="pEFIRES transfection and CaSki KpnB1 (13.9.16).jpeg"/>
            <p:cNvPicPr>
              <a:picLocks noChangeAspect="1"/>
            </p:cNvPicPr>
            <p:nvPr/>
          </p:nvPicPr>
          <p:blipFill rotWithShape="1">
            <a:blip r:embed="rId11" cstate="print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42824" y="5383649"/>
              <a:ext cx="832632" cy="3699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0" name="TextBox 99"/>
            <p:cNvSpPr txBox="1"/>
            <p:nvPr/>
          </p:nvSpPr>
          <p:spPr>
            <a:xfrm>
              <a:off x="4738685" y="5375534"/>
              <a:ext cx="109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/>
                <a:t>Kpn</a:t>
              </a:r>
              <a:r>
                <a:rPr lang="en-GB" sz="800" b="1" dirty="0"/>
                <a:t>β</a:t>
              </a:r>
              <a:r>
                <a:rPr lang="en-US" sz="800" b="1" dirty="0"/>
                <a:t>1-EGFP</a:t>
              </a:r>
            </a:p>
            <a:p>
              <a:endParaRPr lang="en-US" sz="200" b="1" dirty="0"/>
            </a:p>
            <a:p>
              <a:r>
                <a:rPr lang="en-US" sz="800" b="1" dirty="0"/>
                <a:t>KpnB1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738685" y="5852967"/>
              <a:ext cx="20119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E-cadherin 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740450" y="6234698"/>
              <a:ext cx="20119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/>
                <a:t>Vimentin</a:t>
              </a:r>
              <a:endParaRPr lang="en-US" sz="800" b="1" dirty="0"/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4088947" y="4839241"/>
              <a:ext cx="8709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/>
                <a:t>Kpn</a:t>
              </a:r>
              <a:r>
                <a:rPr lang="en-US" sz="800" dirty="0"/>
                <a:t>β1</a:t>
              </a:r>
              <a:r>
                <a:rPr lang="en-US" sz="900" dirty="0"/>
                <a:t>-EGFP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3866494" y="5015492"/>
              <a:ext cx="5338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EGFP</a:t>
              </a:r>
              <a:endParaRPr lang="en-US" sz="900" dirty="0"/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4757011" y="6597852"/>
              <a:ext cx="20119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GAPDH</a:t>
              </a:r>
            </a:p>
          </p:txBody>
        </p:sp>
      </p:grpSp>
      <p:sp>
        <p:nvSpPr>
          <p:cNvPr id="106" name="TextBox 105"/>
          <p:cNvSpPr txBox="1"/>
          <p:nvPr/>
        </p:nvSpPr>
        <p:spPr>
          <a:xfrm>
            <a:off x="85181" y="894263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3958581" y="894263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85181" y="2837676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3961062" y="2833609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85181" y="4837066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3397632" y="4837066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1768788" y="383327"/>
            <a:ext cx="29419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upplementary Figure 1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29329" y="2910554"/>
            <a:ext cx="17378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900" b="1" dirty="0"/>
              <a:t>EGFP</a:t>
            </a:r>
            <a:endParaRPr lang="en-ZA" sz="1000" b="1" dirty="0"/>
          </a:p>
        </p:txBody>
      </p:sp>
      <p:sp>
        <p:nvSpPr>
          <p:cNvPr id="85" name="TextBox 84"/>
          <p:cNvSpPr txBox="1"/>
          <p:nvPr/>
        </p:nvSpPr>
        <p:spPr>
          <a:xfrm>
            <a:off x="2202288" y="2910554"/>
            <a:ext cx="1756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900" b="1" dirty="0"/>
              <a:t>Kpn</a:t>
            </a:r>
            <a:r>
              <a:rPr lang="en-GB" sz="900" dirty="0"/>
              <a:t>β</a:t>
            </a:r>
            <a:r>
              <a:rPr lang="en-ZA" sz="900" b="1" dirty="0"/>
              <a:t>1-EGFP</a:t>
            </a:r>
          </a:p>
        </p:txBody>
      </p:sp>
      <p:graphicFrame>
        <p:nvGraphicFramePr>
          <p:cNvPr id="97" name="Chart 9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0289269"/>
              </p:ext>
            </p:extLst>
          </p:nvPr>
        </p:nvGraphicFramePr>
        <p:xfrm>
          <a:off x="4113127" y="3059662"/>
          <a:ext cx="2286000" cy="1691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-445654" y="7439955"/>
            <a:ext cx="4852624" cy="1693848"/>
            <a:chOff x="-1331622" y="7277211"/>
            <a:chExt cx="7961805" cy="2729974"/>
          </a:xfrm>
        </p:grpSpPr>
        <p:pic>
          <p:nvPicPr>
            <p:cNvPr id="79" name="Picture 3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5531" y="7609853"/>
              <a:ext cx="1524918" cy="11313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8" name="Picture 5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1522" y="7609851"/>
              <a:ext cx="1524918" cy="11313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9" name="Picture 6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02589" y="7593273"/>
              <a:ext cx="1527594" cy="11456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4" name="Picture 7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933" y="8837206"/>
              <a:ext cx="1524920" cy="11436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5" name="Picture 8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5529" y="8837206"/>
              <a:ext cx="1524918" cy="11436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6" name="Picture 9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1522" y="8837206"/>
              <a:ext cx="1559283" cy="11694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7" name="Picture 10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3370" y="8837206"/>
              <a:ext cx="1516806" cy="116997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8" name="Picture 4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4419" y="7609853"/>
              <a:ext cx="1508432" cy="11313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9" name="TextBox 118"/>
            <p:cNvSpPr txBox="1"/>
            <p:nvPr/>
          </p:nvSpPr>
          <p:spPr>
            <a:xfrm>
              <a:off x="-295410" y="7920631"/>
              <a:ext cx="720080" cy="347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b="1" dirty="0"/>
                <a:t>EGFP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591979" y="7277211"/>
              <a:ext cx="1025993" cy="347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0 hour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957908" y="7277211"/>
              <a:ext cx="1440159" cy="347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3 hours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646330" y="7277211"/>
              <a:ext cx="1145660" cy="347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6 hours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5349948" y="7277211"/>
              <a:ext cx="1032875" cy="347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24 hours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-1331622" y="9214932"/>
              <a:ext cx="1756293" cy="347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ZA" sz="800" b="1" dirty="0"/>
                <a:t>Kpn</a:t>
              </a:r>
              <a:r>
                <a:rPr lang="en-GB" sz="800" dirty="0"/>
                <a:t>β</a:t>
              </a:r>
              <a:r>
                <a:rPr lang="en-ZA" sz="800" b="1" dirty="0"/>
                <a:t>1-EGFP</a:t>
              </a:r>
            </a:p>
          </p:txBody>
        </p:sp>
      </p:grpSp>
      <p:graphicFrame>
        <p:nvGraphicFramePr>
          <p:cNvPr id="126" name="Chart 1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224765"/>
              </p:ext>
            </p:extLst>
          </p:nvPr>
        </p:nvGraphicFramePr>
        <p:xfrm>
          <a:off x="4494903" y="7579324"/>
          <a:ext cx="2322576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sp>
        <p:nvSpPr>
          <p:cNvPr id="127" name="TextBox 126"/>
          <p:cNvSpPr txBox="1"/>
          <p:nvPr/>
        </p:nvSpPr>
        <p:spPr>
          <a:xfrm>
            <a:off x="85181" y="7182750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4473643" y="7182750"/>
            <a:ext cx="28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153708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1</TotalTime>
  <Words>74</Words>
  <Application>Microsoft Office PowerPoint</Application>
  <PresentationFormat>A4 Paper (210x297 mm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Carden</dc:creator>
  <cp:lastModifiedBy>Virna Leaner</cp:lastModifiedBy>
  <cp:revision>132</cp:revision>
  <cp:lastPrinted>2017-07-07T09:19:44Z</cp:lastPrinted>
  <dcterms:created xsi:type="dcterms:W3CDTF">2017-03-31T09:11:36Z</dcterms:created>
  <dcterms:modified xsi:type="dcterms:W3CDTF">2018-09-21T10:16:39Z</dcterms:modified>
</cp:coreProperties>
</file>